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120" d="100"/>
          <a:sy n="120" d="100"/>
        </p:scale>
        <p:origin x="-184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hulanbatbayar:Downloads:F1_Pathway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501929019259472"/>
          <c:y val="0.262677183673753"/>
          <c:w val="0.458602613986587"/>
          <c:h val="0.660146782045851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000000"/>
            </a:solidFill>
            <a:effectLst/>
          </c:spPr>
          <c:invertIfNegative val="0"/>
          <c:cat>
            <c:strRef>
              <c:f>Sheet1!$B$2:$B$11</c:f>
              <c:strCache>
                <c:ptCount val="10"/>
                <c:pt idx="0">
                  <c:v>Heme metabolism</c:v>
                </c:pt>
                <c:pt idx="1">
                  <c:v>Cell cycle_Spindle assembly and chromosome separation</c:v>
                </c:pt>
                <c:pt idx="2">
                  <c:v>Proteolysis_Role of Parkin in the Ubiquitin-Proteasomal Pathway</c:v>
                </c:pt>
                <c:pt idx="3">
                  <c:v>Cytoskeleton remodeling_Neurofilaments</c:v>
                </c:pt>
                <c:pt idx="4">
                  <c:v>Cell adhesion_Gap junctions</c:v>
                </c:pt>
                <c:pt idx="5">
                  <c:v>Cell cycle_Role of Nek in cell cycle regulation</c:v>
                </c:pt>
                <c:pt idx="6">
                  <c:v>Nitrogen metabolism</c:v>
                </c:pt>
                <c:pt idx="7">
                  <c:v>Cytoskeleton remodeling_Keratin filaments</c:v>
                </c:pt>
                <c:pt idx="8">
                  <c:v>Nitrogen metabolism/ Rodent version</c:v>
                </c:pt>
                <c:pt idx="9">
                  <c:v>Transcription_Role of AP-1 in regulation of cellular metabolism</c:v>
                </c:pt>
              </c:strCache>
            </c:strRef>
          </c:cat>
          <c:val>
            <c:numRef>
              <c:f>Sheet1!$D$2:$D$11</c:f>
              <c:numCache>
                <c:formatCode>General</c:formatCode>
                <c:ptCount val="10"/>
                <c:pt idx="0">
                  <c:v>4.001304841688344</c:v>
                </c:pt>
                <c:pt idx="1">
                  <c:v>3.98927613460819</c:v>
                </c:pt>
                <c:pt idx="2">
                  <c:v>3.1298888446356</c:v>
                </c:pt>
                <c:pt idx="3">
                  <c:v>3.076704159344496</c:v>
                </c:pt>
                <c:pt idx="4">
                  <c:v>2.84163750790475</c:v>
                </c:pt>
                <c:pt idx="5">
                  <c:v>2.75920122888267</c:v>
                </c:pt>
                <c:pt idx="6">
                  <c:v>2.6458915608526</c:v>
                </c:pt>
                <c:pt idx="7">
                  <c:v>2.610479534153617</c:v>
                </c:pt>
                <c:pt idx="8">
                  <c:v>2.610479534153617</c:v>
                </c:pt>
                <c:pt idx="9">
                  <c:v>2.5425723070535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6974360"/>
        <c:axId val="-2136971208"/>
      </c:barChart>
      <c:catAx>
        <c:axId val="-2136974360"/>
        <c:scaling>
          <c:orientation val="maxMin"/>
        </c:scaling>
        <c:delete val="0"/>
        <c:axPos val="l"/>
        <c:majorTickMark val="out"/>
        <c:minorTickMark val="none"/>
        <c:tickLblPos val="nextTo"/>
        <c:spPr>
          <a:solidFill>
            <a:schemeClr val="bg1">
              <a:lumMod val="95000"/>
            </a:schemeClr>
          </a:solidFill>
        </c:spPr>
        <c:txPr>
          <a:bodyPr/>
          <a:lstStyle/>
          <a:p>
            <a:pPr>
              <a:defRPr sz="1100"/>
            </a:pPr>
            <a:endParaRPr lang="en-US"/>
          </a:p>
        </c:txPr>
        <c:crossAx val="-213697120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-2136971208"/>
        <c:scaling>
          <c:orientation val="minMax"/>
        </c:scaling>
        <c:delete val="0"/>
        <c:axPos val="t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-log(pvalue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36974360"/>
        <c:crosses val="autoZero"/>
        <c:crossBetween val="between"/>
        <c:majorUnit val="1.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solidFill>
      <a:schemeClr val="bg1"/>
    </a:solidFill>
    <a:ln>
      <a:noFill/>
    </a:ln>
    <a:effectLst/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80C8FF-0495-D54F-B728-5A7A8D554948}" type="datetimeFigureOut">
              <a:rPr lang="en-US" smtClean="0"/>
              <a:t>22/09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3E2692-678F-8A42-80A6-E7837876A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9155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B8AF90-509E-BC42-8464-114579A042D5}" type="datetimeFigureOut">
              <a:rPr lang="en-US" smtClean="0"/>
              <a:pPr/>
              <a:t>22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639D9-FA6F-D74B-9983-F30A90C2DA1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/>
          <p:cNvGrpSpPr/>
          <p:nvPr/>
        </p:nvGrpSpPr>
        <p:grpSpPr>
          <a:xfrm>
            <a:off x="190055" y="609466"/>
            <a:ext cx="3839585" cy="6020712"/>
            <a:chOff x="190055" y="859635"/>
            <a:chExt cx="3839585" cy="6020712"/>
          </a:xfrm>
        </p:grpSpPr>
        <p:sp>
          <p:nvSpPr>
            <p:cNvPr id="4" name="TextBox 3"/>
            <p:cNvSpPr txBox="1"/>
            <p:nvPr/>
          </p:nvSpPr>
          <p:spPr>
            <a:xfrm>
              <a:off x="190055" y="859635"/>
              <a:ext cx="2979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 smtClean="0">
                  <a:latin typeface="Arial"/>
                  <a:cs typeface="Arial"/>
                </a:rPr>
                <a:t>Succinyl</a:t>
              </a:r>
              <a:r>
                <a:rPr lang="en-US" sz="1400" dirty="0" smtClean="0">
                  <a:latin typeface="Arial"/>
                  <a:cs typeface="Arial"/>
                </a:rPr>
                <a:t> Co-A + Glycine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68679" y="1442603"/>
              <a:ext cx="1721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Aminolevulinic</a:t>
              </a:r>
              <a:r>
                <a:rPr lang="en-US" sz="1400" dirty="0" smtClean="0">
                  <a:latin typeface="Arial"/>
                  <a:cs typeface="Arial"/>
                </a:rPr>
                <a:t> Acid 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899607" y="2076743"/>
              <a:ext cx="14823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Porphobilinoge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12907" y="2688629"/>
              <a:ext cx="18510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Hydroxymethylbilane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25671" y="3320400"/>
              <a:ext cx="1821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Uroporphyrinogen</a:t>
              </a:r>
              <a:r>
                <a:rPr lang="en-US" sz="1400" dirty="0" smtClean="0">
                  <a:latin typeface="Arial"/>
                  <a:cs typeface="Arial"/>
                </a:rPr>
                <a:t> III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68679" y="3939343"/>
              <a:ext cx="17615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Coporphyrinogen</a:t>
              </a:r>
              <a:r>
                <a:rPr lang="en-US" sz="1400" dirty="0" smtClean="0">
                  <a:latin typeface="Arial"/>
                  <a:cs typeface="Arial"/>
                </a:rPr>
                <a:t> III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53229" y="4583940"/>
              <a:ext cx="19811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Protoporphyrinogen</a:t>
              </a:r>
              <a:r>
                <a:rPr lang="en-US" sz="1400" dirty="0" smtClean="0">
                  <a:latin typeface="Arial"/>
                  <a:cs typeface="Arial"/>
                </a:rPr>
                <a:t> IX</a:t>
              </a:r>
              <a:endParaRPr lang="en-US" sz="1400" dirty="0">
                <a:latin typeface="Arial"/>
                <a:cs typeface="Arial"/>
              </a:endParaRPr>
            </a:p>
          </p:txBody>
        </p:sp>
        <p:grpSp>
          <p:nvGrpSpPr>
            <p:cNvPr id="33" name="Group 32"/>
            <p:cNvGrpSpPr/>
            <p:nvPr/>
          </p:nvGrpSpPr>
          <p:grpSpPr>
            <a:xfrm>
              <a:off x="1941077" y="1109583"/>
              <a:ext cx="683475" cy="3406589"/>
              <a:chOff x="2869617" y="1109583"/>
              <a:chExt cx="683475" cy="3406589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916575" y="1735065"/>
                <a:ext cx="57372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b="1" dirty="0" err="1" smtClean="0">
                    <a:latin typeface="Arial"/>
                    <a:cs typeface="Arial"/>
                  </a:rPr>
                  <a:t>Alad</a:t>
                </a:r>
                <a:endParaRPr lang="en-US" sz="1400" b="1" dirty="0" smtClean="0">
                  <a:latin typeface="Arial"/>
                  <a:cs typeface="Arial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869617" y="2418647"/>
                <a:ext cx="6834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b="1" dirty="0" err="1" smtClean="0">
                    <a:latin typeface="Arial"/>
                    <a:cs typeface="Arial"/>
                  </a:rPr>
                  <a:t>Hmbs</a:t>
                </a:r>
                <a:endParaRPr 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884607" y="3652733"/>
                <a:ext cx="60352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b="1" dirty="0" err="1" smtClean="0">
                    <a:latin typeface="Arial"/>
                    <a:cs typeface="Arial"/>
                  </a:rPr>
                  <a:t>Urod</a:t>
                </a:r>
                <a:endParaRPr 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869617" y="4208395"/>
                <a:ext cx="6335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b="1" dirty="0" err="1" smtClean="0">
                    <a:latin typeface="Arial"/>
                    <a:cs typeface="Arial"/>
                  </a:rPr>
                  <a:t>Cpox</a:t>
                </a:r>
                <a:endParaRPr lang="en-US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904420" y="1109583"/>
                <a:ext cx="5639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Arial"/>
                    <a:cs typeface="Arial"/>
                  </a:rPr>
                  <a:t>Alas</a:t>
                </a:r>
              </a:p>
            </p:txBody>
          </p:sp>
        </p:grpSp>
        <p:sp>
          <p:nvSpPr>
            <p:cNvPr id="17" name="Down Arrow 16"/>
            <p:cNvSpPr/>
            <p:nvPr/>
          </p:nvSpPr>
          <p:spPr>
            <a:xfrm>
              <a:off x="1570370" y="1126397"/>
              <a:ext cx="197869" cy="391953"/>
            </a:xfrm>
            <a:prstGeom prst="downArrow">
              <a:avLst/>
            </a:prstGeom>
            <a:solidFill>
              <a:schemeClr val="tx1"/>
            </a:solidFill>
            <a:ln>
              <a:solidFill>
                <a:srgbClr val="8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rgbClr val="800000"/>
                </a:solidFill>
                <a:latin typeface="Arial"/>
                <a:cs typeface="Arial"/>
              </a:endParaRPr>
            </a:p>
          </p:txBody>
        </p:sp>
        <p:sp>
          <p:nvSpPr>
            <p:cNvPr id="22" name="Down Arrow 21"/>
            <p:cNvSpPr/>
            <p:nvPr/>
          </p:nvSpPr>
          <p:spPr>
            <a:xfrm>
              <a:off x="1570370" y="1744445"/>
              <a:ext cx="197869" cy="391953"/>
            </a:xfrm>
            <a:prstGeom prst="downArrow">
              <a:avLst/>
            </a:prstGeom>
            <a:solidFill>
              <a:schemeClr val="tx1"/>
            </a:solidFill>
            <a:ln>
              <a:solidFill>
                <a:srgbClr val="8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rgbClr val="800000"/>
                </a:solidFill>
                <a:latin typeface="Arial"/>
                <a:cs typeface="Arial"/>
              </a:endParaRPr>
            </a:p>
          </p:txBody>
        </p:sp>
        <p:sp>
          <p:nvSpPr>
            <p:cNvPr id="23" name="Down Arrow 22"/>
            <p:cNvSpPr/>
            <p:nvPr/>
          </p:nvSpPr>
          <p:spPr>
            <a:xfrm>
              <a:off x="1570370" y="2381089"/>
              <a:ext cx="197869" cy="391953"/>
            </a:xfrm>
            <a:prstGeom prst="downArrow">
              <a:avLst/>
            </a:prstGeom>
            <a:solidFill>
              <a:schemeClr val="tx1"/>
            </a:solidFill>
            <a:ln>
              <a:solidFill>
                <a:srgbClr val="8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rgbClr val="800000"/>
                </a:solidFill>
                <a:latin typeface="Arial"/>
                <a:cs typeface="Arial"/>
              </a:endParaRPr>
            </a:p>
          </p:txBody>
        </p:sp>
        <p:sp>
          <p:nvSpPr>
            <p:cNvPr id="24" name="Down Arrow 23"/>
            <p:cNvSpPr/>
            <p:nvPr/>
          </p:nvSpPr>
          <p:spPr>
            <a:xfrm>
              <a:off x="1570370" y="3020020"/>
              <a:ext cx="197869" cy="391953"/>
            </a:xfrm>
            <a:prstGeom prst="downArrow">
              <a:avLst/>
            </a:prstGeom>
            <a:solidFill>
              <a:schemeClr val="tx1"/>
            </a:solidFill>
            <a:ln>
              <a:solidFill>
                <a:srgbClr val="8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rgbClr val="800000"/>
                </a:solidFill>
                <a:latin typeface="Arial"/>
                <a:cs typeface="Arial"/>
              </a:endParaRPr>
            </a:p>
          </p:txBody>
        </p:sp>
        <p:sp>
          <p:nvSpPr>
            <p:cNvPr id="25" name="Down Arrow 24"/>
            <p:cNvSpPr/>
            <p:nvPr/>
          </p:nvSpPr>
          <p:spPr>
            <a:xfrm>
              <a:off x="1570370" y="3634918"/>
              <a:ext cx="197869" cy="391953"/>
            </a:xfrm>
            <a:prstGeom prst="downArrow">
              <a:avLst/>
            </a:prstGeom>
            <a:solidFill>
              <a:schemeClr val="tx1"/>
            </a:solidFill>
            <a:ln>
              <a:solidFill>
                <a:srgbClr val="8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rgbClr val="800000"/>
                </a:solidFill>
                <a:latin typeface="Arial"/>
                <a:cs typeface="Arial"/>
              </a:endParaRPr>
            </a:p>
          </p:txBody>
        </p:sp>
        <p:sp>
          <p:nvSpPr>
            <p:cNvPr id="26" name="Down Arrow 25"/>
            <p:cNvSpPr/>
            <p:nvPr/>
          </p:nvSpPr>
          <p:spPr>
            <a:xfrm>
              <a:off x="1570370" y="4231545"/>
              <a:ext cx="197869" cy="391953"/>
            </a:xfrm>
            <a:prstGeom prst="downArrow">
              <a:avLst/>
            </a:prstGeom>
            <a:solidFill>
              <a:schemeClr val="tx1"/>
            </a:solidFill>
            <a:ln>
              <a:solidFill>
                <a:srgbClr val="8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rgbClr val="800000"/>
                </a:solidFill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64340" y="5199222"/>
              <a:ext cx="15817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Protoporphyrin</a:t>
              </a:r>
              <a:r>
                <a:rPr lang="en-US" sz="1400" dirty="0" smtClean="0">
                  <a:latin typeface="Arial"/>
                  <a:cs typeface="Arial"/>
                </a:rPr>
                <a:t> IX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314378" y="5946886"/>
              <a:ext cx="673657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 err="1" smtClean="0">
                  <a:latin typeface="Arial"/>
                  <a:cs typeface="Arial"/>
                </a:rPr>
                <a:t>Heme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41188" y="6569784"/>
              <a:ext cx="1352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Heme</a:t>
              </a:r>
              <a:r>
                <a:rPr lang="en-US" sz="1400" dirty="0" smtClean="0">
                  <a:latin typeface="Arial"/>
                  <a:cs typeface="Arial"/>
                </a:rPr>
                <a:t> proteins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956067" y="6569784"/>
              <a:ext cx="9130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/>
                  <a:cs typeface="Arial"/>
                </a:rPr>
                <a:t>Biliverdi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206340" y="6572570"/>
              <a:ext cx="8233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Bilirubin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732363" y="6377922"/>
              <a:ext cx="64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err="1" smtClean="0">
                  <a:latin typeface="Arial"/>
                  <a:cs typeface="Arial"/>
                </a:rPr>
                <a:t>Blvrb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27821" y="6254661"/>
              <a:ext cx="8934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cyp2c23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39" name="Right Arrow 38"/>
            <p:cNvSpPr/>
            <p:nvPr/>
          </p:nvSpPr>
          <p:spPr>
            <a:xfrm rot="2645584" flipV="1">
              <a:off x="1939732" y="6372206"/>
              <a:ext cx="403232" cy="16143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/>
                <a:cs typeface="Arial"/>
              </a:endParaRPr>
            </a:p>
          </p:txBody>
        </p:sp>
        <p:sp>
          <p:nvSpPr>
            <p:cNvPr id="40" name="Right Arrow 39"/>
            <p:cNvSpPr/>
            <p:nvPr/>
          </p:nvSpPr>
          <p:spPr>
            <a:xfrm flipV="1">
              <a:off x="2869135" y="6661707"/>
              <a:ext cx="337205" cy="168095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/>
                <a:cs typeface="Arial"/>
              </a:endParaRPr>
            </a:p>
          </p:txBody>
        </p:sp>
      </p:grpSp>
      <p:sp>
        <p:nvSpPr>
          <p:cNvPr id="41" name="TextBox 40"/>
          <p:cNvSpPr txBox="1"/>
          <p:nvPr/>
        </p:nvSpPr>
        <p:spPr>
          <a:xfrm>
            <a:off x="184159" y="68555"/>
            <a:ext cx="2814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1</a:t>
            </a:r>
            <a:endParaRPr lang="en-US" b="1" dirty="0">
              <a:latin typeface="Arial"/>
              <a:cs typeface="Arial"/>
            </a:endParaRPr>
          </a:p>
        </p:txBody>
      </p:sp>
      <p:graphicFrame>
        <p:nvGraphicFramePr>
          <p:cNvPr id="43" name="Chart 42"/>
          <p:cNvGraphicFramePr/>
          <p:nvPr>
            <p:extLst>
              <p:ext uri="{D42A27DB-BD31-4B8C-83A1-F6EECF244321}">
                <p14:modId xmlns:p14="http://schemas.microsoft.com/office/powerpoint/2010/main" val="562155606"/>
              </p:ext>
            </p:extLst>
          </p:nvPr>
        </p:nvGraphicFramePr>
        <p:xfrm>
          <a:off x="3206340" y="499946"/>
          <a:ext cx="5544093" cy="29823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4" name="Down Arrow 43"/>
          <p:cNvSpPr/>
          <p:nvPr/>
        </p:nvSpPr>
        <p:spPr>
          <a:xfrm>
            <a:off x="1568822" y="4646896"/>
            <a:ext cx="197869" cy="391953"/>
          </a:xfrm>
          <a:prstGeom prst="downArrow">
            <a:avLst/>
          </a:prstGeom>
          <a:solidFill>
            <a:schemeClr val="tx1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solidFill>
                <a:srgbClr val="800000"/>
              </a:solidFill>
              <a:latin typeface="Arial"/>
              <a:cs typeface="Arial"/>
            </a:endParaRPr>
          </a:p>
        </p:txBody>
      </p:sp>
      <p:sp>
        <p:nvSpPr>
          <p:cNvPr id="45" name="Down Arrow 44"/>
          <p:cNvSpPr/>
          <p:nvPr/>
        </p:nvSpPr>
        <p:spPr>
          <a:xfrm>
            <a:off x="1554445" y="5286760"/>
            <a:ext cx="197869" cy="391953"/>
          </a:xfrm>
          <a:prstGeom prst="downArrow">
            <a:avLst/>
          </a:prstGeom>
          <a:solidFill>
            <a:schemeClr val="tx1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solidFill>
                <a:srgbClr val="800000"/>
              </a:solidFill>
              <a:latin typeface="Arial"/>
              <a:cs typeface="Arial"/>
            </a:endParaRPr>
          </a:p>
        </p:txBody>
      </p:sp>
      <p:sp>
        <p:nvSpPr>
          <p:cNvPr id="47" name="Right Arrow 46"/>
          <p:cNvSpPr/>
          <p:nvPr/>
        </p:nvSpPr>
        <p:spPr>
          <a:xfrm rot="7967741" flipV="1">
            <a:off x="976009" y="6146157"/>
            <a:ext cx="403232" cy="16143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atin typeface="Arial"/>
              <a:cs typeface="Arial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84159" y="609466"/>
            <a:ext cx="461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3798694" y="609466"/>
            <a:ext cx="461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24450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47</TotalTime>
  <Words>40</Words>
  <Application>Microsoft Macintosh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hulan Batbayar</dc:creator>
  <cp:lastModifiedBy>Mandy Drake</cp:lastModifiedBy>
  <cp:revision>63</cp:revision>
  <dcterms:created xsi:type="dcterms:W3CDTF">2015-01-02T16:16:29Z</dcterms:created>
  <dcterms:modified xsi:type="dcterms:W3CDTF">2015-09-22T14:35:38Z</dcterms:modified>
</cp:coreProperties>
</file>